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  <p:sldId id="281" r:id="rId3"/>
    <p:sldId id="257" r:id="rId4"/>
    <p:sldId id="282" r:id="rId5"/>
    <p:sldId id="280" r:id="rId6"/>
    <p:sldId id="283" r:id="rId7"/>
    <p:sldId id="289" r:id="rId8"/>
    <p:sldId id="290" r:id="rId9"/>
    <p:sldId id="287" r:id="rId10"/>
    <p:sldId id="288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817" autoAdjust="0"/>
  </p:normalViewPr>
  <p:slideViewPr>
    <p:cSldViewPr snapToGrid="0">
      <p:cViewPr varScale="1">
        <p:scale>
          <a:sx n="91" d="100"/>
          <a:sy n="91" d="100"/>
        </p:scale>
        <p:origin x="283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0975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158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1630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3369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781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73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57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29012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0140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9784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6974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917B9-4A2F-451A-AE2D-23737137D6FE}" type="datetimeFigureOut">
              <a:rPr kumimoji="1" lang="ja-JP" altLang="en-US" smtClean="0"/>
              <a:t>2023/6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00403-9D3F-40DB-A97F-DEDFF95FC5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0268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ti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3F642DB-90B9-49D0-B971-14DF006951AB}"/>
              </a:ext>
            </a:extLst>
          </p:cNvPr>
          <p:cNvSpPr txBox="1"/>
          <p:nvPr/>
        </p:nvSpPr>
        <p:spPr>
          <a:xfrm>
            <a:off x="1" y="0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/>
              <a:t>Supplementary Figure 1: Effects of SCFAs on HK-2 cell viability and cytotoxicity under </a:t>
            </a:r>
            <a:r>
              <a:rPr lang="en-US" altLang="ja-JP" sz="2400" dirty="0" err="1"/>
              <a:t>normoxia</a:t>
            </a:r>
            <a:r>
              <a:rPr lang="en-US" altLang="ja-JP" sz="2400" dirty="0"/>
              <a:t>.</a:t>
            </a:r>
            <a:endParaRPr lang="en-US" altLang="ja-JP" sz="2400" dirty="0">
              <a:highlight>
                <a:srgbClr val="FFFF00"/>
              </a:highlight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1EB551B-F7AB-2F8F-9B74-7D5260C13CBE}"/>
              </a:ext>
            </a:extLst>
          </p:cNvPr>
          <p:cNvSpPr txBox="1"/>
          <p:nvPr/>
        </p:nvSpPr>
        <p:spPr>
          <a:xfrm>
            <a:off x="39349" y="1731188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a)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E2F5292-BE15-F058-CEAE-9260902DF8FC}"/>
              </a:ext>
            </a:extLst>
          </p:cNvPr>
          <p:cNvSpPr txBox="1"/>
          <p:nvPr/>
        </p:nvSpPr>
        <p:spPr>
          <a:xfrm>
            <a:off x="3429000" y="1731188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b)</a:t>
            </a:r>
            <a:endParaRPr lang="ja-JP" altLang="en-US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1B0A4EB-63FE-7616-3F8A-E0BC76EBB1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49" y="2100520"/>
            <a:ext cx="6858000" cy="3504815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80A1A18-7E7B-2EAB-2AA0-0FD62B6A2C1B}"/>
              </a:ext>
            </a:extLst>
          </p:cNvPr>
          <p:cNvSpPr txBox="1"/>
          <p:nvPr/>
        </p:nvSpPr>
        <p:spPr>
          <a:xfrm>
            <a:off x="944457" y="5297558"/>
            <a:ext cx="205099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　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　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u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6C406B7-D52A-B51A-26CF-71DE5E55D928}"/>
              </a:ext>
            </a:extLst>
          </p:cNvPr>
          <p:cNvSpPr txBox="1"/>
          <p:nvPr/>
        </p:nvSpPr>
        <p:spPr>
          <a:xfrm>
            <a:off x="4370830" y="5297558"/>
            <a:ext cx="205099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 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　</a:t>
            </a:r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　</a:t>
            </a:r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u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0920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089D6B-0745-921E-DC40-AAC4BA6CDAFD}"/>
              </a:ext>
            </a:extLst>
          </p:cNvPr>
          <p:cNvSpPr txBox="1"/>
          <p:nvPr/>
        </p:nvSpPr>
        <p:spPr>
          <a:xfrm>
            <a:off x="409903" y="479501"/>
            <a:ext cx="6064469" cy="225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5. No significant difference was seen in transcription of mRNA of fission/fusion genes between the control and acetate treatment in UUO mice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-d) Effects of acetate on fission/fusion gene expression in UUO mice (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n=8;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c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n=7)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ata are expressed as the mean ± SEM. *P &lt; 0.05, compared with the control (t-test)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vehicle; Ac, acetate; Fis1, fission protein 1; Drp1, Dynamin-1-like protein; Opa1, optic atrophy 1; Mfn2,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itofusi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.</a:t>
            </a:r>
          </a:p>
        </p:txBody>
      </p:sp>
    </p:spTree>
    <p:extLst>
      <p:ext uri="{BB962C8B-B14F-4D97-AF65-F5344CB8AC3E}">
        <p14:creationId xmlns:p14="http://schemas.microsoft.com/office/powerpoint/2010/main" val="1763327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6E18AB8-ACD8-BA1D-6EC3-7C981CC49A53}"/>
              </a:ext>
            </a:extLst>
          </p:cNvPr>
          <p:cNvSpPr txBox="1"/>
          <p:nvPr/>
        </p:nvSpPr>
        <p:spPr>
          <a:xfrm>
            <a:off x="409903" y="479501"/>
            <a:ext cx="6064469" cy="22566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. Effects of SCFAs on HK-2 cell viability and cytotoxicity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Cell viability and (b) cytotoxicity with 0.5 mM SCFA under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ormoxi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for 19 h (n=4 in each group)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ata are expressed as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ean ± SEM. The statistical differences were quantified using one-way ANOVA analysis with Dunnett’s multiple comparisons test. *P &lt; 0.05, compared with the control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vehicle; Ac, acetate;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propionate; Bu, butyrate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68662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A61B9B-E760-AE8F-1C7F-7645922FE900}"/>
              </a:ext>
            </a:extLst>
          </p:cNvPr>
          <p:cNvSpPr txBox="1"/>
          <p:nvPr/>
        </p:nvSpPr>
        <p:spPr>
          <a:xfrm>
            <a:off x="1" y="0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/>
              <a:t>Supplementary Figure 2: Acetate and propionate partially elevated antioxidant mRNA expression under oxidative stress in HK-2 cells.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204AE8D-10E8-B8BC-E097-CF2F79E876A1}"/>
              </a:ext>
            </a:extLst>
          </p:cNvPr>
          <p:cNvSpPr txBox="1"/>
          <p:nvPr/>
        </p:nvSpPr>
        <p:spPr>
          <a:xfrm>
            <a:off x="617171" y="1202145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a)</a:t>
            </a:r>
            <a:endParaRPr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A1AA09C-3530-AF49-998A-005F7B49FDE0}"/>
              </a:ext>
            </a:extLst>
          </p:cNvPr>
          <p:cNvSpPr txBox="1"/>
          <p:nvPr/>
        </p:nvSpPr>
        <p:spPr>
          <a:xfrm>
            <a:off x="3178789" y="1202145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b)</a:t>
            </a:r>
            <a:endParaRPr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C0613B1-81C9-E3D1-C241-345BC9F69863}"/>
              </a:ext>
            </a:extLst>
          </p:cNvPr>
          <p:cNvSpPr txBox="1"/>
          <p:nvPr/>
        </p:nvSpPr>
        <p:spPr>
          <a:xfrm>
            <a:off x="774827" y="4161819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c)</a:t>
            </a:r>
            <a:endParaRPr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DD46BB5-C077-80EC-627C-9BF334E88F69}"/>
              </a:ext>
            </a:extLst>
          </p:cNvPr>
          <p:cNvSpPr txBox="1"/>
          <p:nvPr/>
        </p:nvSpPr>
        <p:spPr>
          <a:xfrm>
            <a:off x="3178789" y="4161819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d)</a:t>
            </a:r>
            <a:endParaRPr lang="ja-JP" altLang="en-US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5CDABF7-FE8A-5B31-42E6-5331F821ED1D}"/>
              </a:ext>
            </a:extLst>
          </p:cNvPr>
          <p:cNvSpPr txBox="1"/>
          <p:nvPr/>
        </p:nvSpPr>
        <p:spPr>
          <a:xfrm>
            <a:off x="774827" y="6936827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e)</a:t>
            </a:r>
            <a:endParaRPr lang="ja-JP" altLang="en-US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2F73AEB1-A387-7192-D2B9-8E0A7BF55C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168" y="1217279"/>
            <a:ext cx="4213156" cy="311407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E376E209-B30F-2881-88FB-0A18AACF56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3168" y="3990471"/>
            <a:ext cx="4324728" cy="3221073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05CA358B-1F75-BEEA-2810-B776046FDEF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038" y="7104543"/>
            <a:ext cx="2311407" cy="2886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21760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089D6B-0745-921E-DC40-AAC4BA6CDAFD}"/>
              </a:ext>
            </a:extLst>
          </p:cNvPr>
          <p:cNvSpPr txBox="1"/>
          <p:nvPr/>
        </p:nvSpPr>
        <p:spPr>
          <a:xfrm>
            <a:off x="409903" y="479501"/>
            <a:ext cx="6064469" cy="29906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. Acetate and propionate partially elevated antioxidant mRNA expression under oxidative stress in HK-2 cells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-e) Effects of SCFAs on antioxidant gene expression under hypoxia for 16 h (n=3 in each group)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ata are expressed as the mean ± SEM. The statistical differences were quantified using one-way ANOVA analysis with Dunnett’s multiple comparisons test. *P &lt; 0.05, ** P &lt; 0.01 compared with control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vehicle; Ac, acetate;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propionate; Bu, butyrate; CAT, catalase; CYCS, cytochrome c; HMOX1, heme oxygenase 1; SOD, superoxide dismutase; </a:t>
            </a:r>
          </a:p>
        </p:txBody>
      </p:sp>
    </p:spTree>
    <p:extLst>
      <p:ext uri="{BB962C8B-B14F-4D97-AF65-F5344CB8AC3E}">
        <p14:creationId xmlns:p14="http://schemas.microsoft.com/office/powerpoint/2010/main" val="18451272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6F426F34-2E74-D862-8853-19937573D9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898" y="1057620"/>
            <a:ext cx="4079817" cy="314964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682BC9F-18E6-F540-D260-8FE5D889A4BB}"/>
              </a:ext>
            </a:extLst>
          </p:cNvPr>
          <p:cNvSpPr txBox="1"/>
          <p:nvPr/>
        </p:nvSpPr>
        <p:spPr>
          <a:xfrm>
            <a:off x="1" y="0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/>
              <a:t>Supplementary Figure 3: Acetate did not attenuate mitochondrial respiration under oxidative stress in HK-2 cells.</a:t>
            </a:r>
            <a:endParaRPr lang="en-US" altLang="ja-JP" sz="26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FC5AB95-7144-CBB1-9DAA-17AD2711AB99}"/>
              </a:ext>
            </a:extLst>
          </p:cNvPr>
          <p:cNvSpPr txBox="1"/>
          <p:nvPr/>
        </p:nvSpPr>
        <p:spPr>
          <a:xfrm>
            <a:off x="1112093" y="1096226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a)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DE7829D-B6B3-909B-CB09-F43D0F475233}"/>
              </a:ext>
            </a:extLst>
          </p:cNvPr>
          <p:cNvSpPr txBox="1"/>
          <p:nvPr/>
        </p:nvSpPr>
        <p:spPr>
          <a:xfrm>
            <a:off x="932932" y="4313637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b)</a:t>
            </a:r>
            <a:endParaRPr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3FAB2E4-2186-D89A-2919-36346F565046}"/>
              </a:ext>
            </a:extLst>
          </p:cNvPr>
          <p:cNvSpPr txBox="1"/>
          <p:nvPr/>
        </p:nvSpPr>
        <p:spPr>
          <a:xfrm>
            <a:off x="3343806" y="4313637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c)</a:t>
            </a:r>
            <a:endParaRPr lang="ja-JP" altLang="en-US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748C4E7-8BB2-C19B-055A-19A8C8B336F4}"/>
              </a:ext>
            </a:extLst>
          </p:cNvPr>
          <p:cNvSpPr txBox="1"/>
          <p:nvPr/>
        </p:nvSpPr>
        <p:spPr>
          <a:xfrm>
            <a:off x="932932" y="7346382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d)</a:t>
            </a:r>
            <a:endParaRPr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8AE44B1-BE7F-FEAA-039D-296CC34485EB}"/>
              </a:ext>
            </a:extLst>
          </p:cNvPr>
          <p:cNvSpPr txBox="1"/>
          <p:nvPr/>
        </p:nvSpPr>
        <p:spPr>
          <a:xfrm>
            <a:off x="3343806" y="7346382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e)</a:t>
            </a:r>
            <a:endParaRPr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55FA934-CAF0-9A47-8E18-0FEE4239C410}"/>
              </a:ext>
            </a:extLst>
          </p:cNvPr>
          <p:cNvSpPr txBox="1"/>
          <p:nvPr/>
        </p:nvSpPr>
        <p:spPr>
          <a:xfrm>
            <a:off x="4550241" y="1897946"/>
            <a:ext cx="594571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  <a:p>
            <a:r>
              <a:rPr kumimoji="1"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　 </a:t>
            </a: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32461689-FD3E-B7B7-4282-8B74482549F6}"/>
              </a:ext>
            </a:extLst>
          </p:cNvPr>
          <p:cNvGrpSpPr/>
          <p:nvPr/>
        </p:nvGrpSpPr>
        <p:grpSpPr>
          <a:xfrm>
            <a:off x="1362304" y="4445050"/>
            <a:ext cx="4154656" cy="2747315"/>
            <a:chOff x="1362304" y="4445050"/>
            <a:chExt cx="4154656" cy="2747315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94A251BD-B413-000A-888C-54A6DE039CC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2304" y="4445050"/>
              <a:ext cx="4154656" cy="2726643"/>
            </a:xfrm>
            <a:prstGeom prst="rect">
              <a:avLst/>
            </a:prstGeom>
          </p:spPr>
        </p:pic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BF32105-9A3C-D972-C735-744A5188EFB3}"/>
                </a:ext>
              </a:extLst>
            </p:cNvPr>
            <p:cNvSpPr txBox="1"/>
            <p:nvPr/>
          </p:nvSpPr>
          <p:spPr>
            <a:xfrm>
              <a:off x="1984981" y="6894694"/>
              <a:ext cx="88434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　 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B8BD91E-7B60-C475-0A6E-C38CE0F246E3}"/>
                </a:ext>
              </a:extLst>
            </p:cNvPr>
            <p:cNvSpPr txBox="1"/>
            <p:nvPr/>
          </p:nvSpPr>
          <p:spPr>
            <a:xfrm>
              <a:off x="4186898" y="6915366"/>
              <a:ext cx="88434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　 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1773498B-7AAA-44F3-0D36-3BBC931D3136}"/>
              </a:ext>
            </a:extLst>
          </p:cNvPr>
          <p:cNvGrpSpPr/>
          <p:nvPr/>
        </p:nvGrpSpPr>
        <p:grpSpPr>
          <a:xfrm>
            <a:off x="1362304" y="7356231"/>
            <a:ext cx="4154656" cy="2506369"/>
            <a:chOff x="1362304" y="7356231"/>
            <a:chExt cx="4154656" cy="250636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5CA7B45B-6962-581D-EF1E-555894A588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2304" y="7356231"/>
              <a:ext cx="4154656" cy="2496520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EEE58928-C993-2A86-19A6-2701E3D80460}"/>
                </a:ext>
              </a:extLst>
            </p:cNvPr>
            <p:cNvSpPr txBox="1"/>
            <p:nvPr/>
          </p:nvSpPr>
          <p:spPr>
            <a:xfrm>
              <a:off x="2074318" y="9585601"/>
              <a:ext cx="88434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　 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A8D44ED-0D44-FE6E-7997-77C2B2973BCC}"/>
                </a:ext>
              </a:extLst>
            </p:cNvPr>
            <p:cNvSpPr txBox="1"/>
            <p:nvPr/>
          </p:nvSpPr>
          <p:spPr>
            <a:xfrm>
              <a:off x="4186898" y="9585601"/>
              <a:ext cx="88434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　 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462198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089D6B-0745-921E-DC40-AAC4BA6CDAFD}"/>
              </a:ext>
            </a:extLst>
          </p:cNvPr>
          <p:cNvSpPr txBox="1"/>
          <p:nvPr/>
        </p:nvSpPr>
        <p:spPr>
          <a:xfrm>
            <a:off x="409903" y="479501"/>
            <a:ext cx="6064469" cy="37293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3. Acetate did not attenuate mitochondrial respiration under oxidative stress in HK-2 cells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A schematic overview of a mitochondrial stress test. Arrows indicate the addition of oligomycin, ATPase inhibitor; FCCP, uncoupling reagent; and rotenone and antimycin A, inhibitors of the electron transport chain. OCR was normalized to total cellular protein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-e)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 significant difference was observed in mitochondrial respiration between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c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n=4 in each group). 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ata are expressed as the mean ± SEM. *P &lt; 0.05, compared with the control (t-test)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vehicle; Ac, acetate; FCCP,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rbonilcyanid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-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riflouromethoxyphenylhydrazon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; OCR, oxygen consumption rate</a:t>
            </a:r>
          </a:p>
        </p:txBody>
      </p:sp>
    </p:spTree>
    <p:extLst>
      <p:ext uri="{BB962C8B-B14F-4D97-AF65-F5344CB8AC3E}">
        <p14:creationId xmlns:p14="http://schemas.microsoft.com/office/powerpoint/2010/main" val="8297980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E5BE5A7-B920-071C-5EE2-87D4C6975F39}"/>
              </a:ext>
            </a:extLst>
          </p:cNvPr>
          <p:cNvSpPr txBox="1"/>
          <p:nvPr/>
        </p:nvSpPr>
        <p:spPr>
          <a:xfrm>
            <a:off x="1" y="0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/>
              <a:t>Supplementary Figure 4: The area stained with γH2AX were considered tubules.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DF312F6-394B-2992-2886-1C4D89908B70}"/>
              </a:ext>
            </a:extLst>
          </p:cNvPr>
          <p:cNvSpPr txBox="1"/>
          <p:nvPr/>
        </p:nvSpPr>
        <p:spPr>
          <a:xfrm>
            <a:off x="0" y="1951478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a)</a:t>
            </a:r>
            <a:endParaRPr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BBA1F19-24F2-0331-FE6F-B0A7C83F271A}"/>
              </a:ext>
            </a:extLst>
          </p:cNvPr>
          <p:cNvSpPr txBox="1"/>
          <p:nvPr/>
        </p:nvSpPr>
        <p:spPr>
          <a:xfrm>
            <a:off x="2392936" y="1951478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b)</a:t>
            </a:r>
            <a:endParaRPr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C412A4-BE45-1631-C235-238D5A51F19E}"/>
              </a:ext>
            </a:extLst>
          </p:cNvPr>
          <p:cNvSpPr txBox="1"/>
          <p:nvPr/>
        </p:nvSpPr>
        <p:spPr>
          <a:xfrm>
            <a:off x="4625468" y="1951478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c)</a:t>
            </a:r>
            <a:endParaRPr lang="ja-JP" altLang="en-US" dirty="0"/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EC22541B-22E0-DFB5-BEEE-E6BFD08D980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638"/>
          <a:stretch/>
        </p:blipFill>
        <p:spPr>
          <a:xfrm>
            <a:off x="0" y="2136144"/>
            <a:ext cx="6858000" cy="19820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64812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3089D6B-0745-921E-DC40-AAC4BA6CDAFD}"/>
              </a:ext>
            </a:extLst>
          </p:cNvPr>
          <p:cNvSpPr txBox="1"/>
          <p:nvPr/>
        </p:nvSpPr>
        <p:spPr>
          <a:xfrm>
            <a:off x="409903" y="479501"/>
            <a:ext cx="6064469" cy="15133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e area stained with γH2AX were considered mainly</a:t>
            </a:r>
            <a:r>
              <a:rPr lang="ja-JP" altLang="en-US" sz="1200" b="1" kern="10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ubules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</a:p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-c) Immunofluorescence staining for </a:t>
            </a:r>
            <a:r>
              <a:rPr lang="el-GR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γ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2AX and DAPI. In the low power field of the staining, the area thought to be glomerulus were not stained with γH2AX (arrow).</a:t>
            </a:r>
          </a:p>
          <a:p>
            <a:pPr algn="just">
              <a:lnSpc>
                <a:spcPct val="200000"/>
              </a:lnSpc>
            </a:pPr>
            <a:r>
              <a:rPr lang="el-GR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γ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2AX, phosphorylated histone H2AX; DAPI, 4',6-diamidino-2-phenylindole Scale bars, 10</a:t>
            </a:r>
            <a:r>
              <a:rPr lang="el-GR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μ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36982601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E5BE5A7-B920-071C-5EE2-87D4C6975F39}"/>
              </a:ext>
            </a:extLst>
          </p:cNvPr>
          <p:cNvSpPr txBox="1"/>
          <p:nvPr/>
        </p:nvSpPr>
        <p:spPr>
          <a:xfrm>
            <a:off x="1" y="0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/>
              <a:t>Supplementary Figure 5: No significant difference was observed in transcription of mRNA of fission/fusion genes between the control and acetate treatment in UUO mice.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DF312F6-394B-2992-2886-1C4D89908B70}"/>
              </a:ext>
            </a:extLst>
          </p:cNvPr>
          <p:cNvSpPr txBox="1"/>
          <p:nvPr/>
        </p:nvSpPr>
        <p:spPr>
          <a:xfrm>
            <a:off x="761725" y="1981959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a)</a:t>
            </a:r>
            <a:endParaRPr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BBA1F19-24F2-0331-FE6F-B0A7C83F271A}"/>
              </a:ext>
            </a:extLst>
          </p:cNvPr>
          <p:cNvSpPr txBox="1"/>
          <p:nvPr/>
        </p:nvSpPr>
        <p:spPr>
          <a:xfrm>
            <a:off x="3340790" y="1981959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b)</a:t>
            </a:r>
            <a:endParaRPr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EC412A4-BE45-1631-C235-238D5A51F19E}"/>
              </a:ext>
            </a:extLst>
          </p:cNvPr>
          <p:cNvSpPr txBox="1"/>
          <p:nvPr/>
        </p:nvSpPr>
        <p:spPr>
          <a:xfrm>
            <a:off x="761725" y="5255007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c)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F2D7182-48CA-6EC3-848E-126F294F1FA0}"/>
              </a:ext>
            </a:extLst>
          </p:cNvPr>
          <p:cNvSpPr txBox="1"/>
          <p:nvPr/>
        </p:nvSpPr>
        <p:spPr>
          <a:xfrm>
            <a:off x="3429000" y="5255007"/>
            <a:ext cx="5004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(d)</a:t>
            </a:r>
            <a:endParaRPr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F08858B4-61E3-5608-E01B-EB4B25C6513C}"/>
              </a:ext>
            </a:extLst>
          </p:cNvPr>
          <p:cNvGrpSpPr/>
          <p:nvPr/>
        </p:nvGrpSpPr>
        <p:grpSpPr>
          <a:xfrm>
            <a:off x="893246" y="1719798"/>
            <a:ext cx="5413518" cy="3417999"/>
            <a:chOff x="893246" y="1719798"/>
            <a:chExt cx="5413518" cy="3417999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5BCAC91A-682B-66BF-515A-8E5624FBD3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3246" y="1719798"/>
              <a:ext cx="5413518" cy="3417999"/>
            </a:xfrm>
            <a:prstGeom prst="rect">
              <a:avLst/>
            </a:prstGeom>
          </p:spPr>
        </p:pic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7C49BCD3-1E71-92C4-C6A1-8A940CCC0A36}"/>
                </a:ext>
              </a:extLst>
            </p:cNvPr>
            <p:cNvSpPr txBox="1"/>
            <p:nvPr/>
          </p:nvSpPr>
          <p:spPr>
            <a:xfrm>
              <a:off x="1660637" y="4517972"/>
              <a:ext cx="107205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　  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52E1CFA5-00F2-6FF4-BCE1-2A3E437FD815}"/>
                </a:ext>
              </a:extLst>
            </p:cNvPr>
            <p:cNvSpPr txBox="1"/>
            <p:nvPr/>
          </p:nvSpPr>
          <p:spPr>
            <a:xfrm>
              <a:off x="4734913" y="4486150"/>
              <a:ext cx="107205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　  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1449BCD6-ADCC-1574-B196-D159B001E206}"/>
              </a:ext>
            </a:extLst>
          </p:cNvPr>
          <p:cNvGrpSpPr/>
          <p:nvPr/>
        </p:nvGrpSpPr>
        <p:grpSpPr>
          <a:xfrm>
            <a:off x="893246" y="5318439"/>
            <a:ext cx="5472094" cy="3540766"/>
            <a:chOff x="893246" y="5318439"/>
            <a:chExt cx="5472094" cy="3540766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5923B802-E561-7018-D123-477C6268CE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3246" y="5318439"/>
              <a:ext cx="5472094" cy="3540766"/>
            </a:xfrm>
            <a:prstGeom prst="rect">
              <a:avLst/>
            </a:prstGeom>
          </p:spPr>
        </p:pic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EE010006-EE3C-24FA-BD27-D03E6D39DAC9}"/>
                </a:ext>
              </a:extLst>
            </p:cNvPr>
            <p:cNvSpPr txBox="1"/>
            <p:nvPr/>
          </p:nvSpPr>
          <p:spPr>
            <a:xfrm>
              <a:off x="1860334" y="8186202"/>
              <a:ext cx="107205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　  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51CE15CE-8EE9-7DB5-A0B9-6B14DD8CDFF5}"/>
                </a:ext>
              </a:extLst>
            </p:cNvPr>
            <p:cNvSpPr txBox="1"/>
            <p:nvPr/>
          </p:nvSpPr>
          <p:spPr>
            <a:xfrm>
              <a:off x="4734913" y="8255196"/>
              <a:ext cx="107205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　  </a:t>
              </a:r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c</a:t>
              </a:r>
              <a:r>
                <a:rPr kumimoji="1" lang="ja-JP" alt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5909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41</TotalTime>
  <Words>681</Words>
  <Application>Microsoft Office PowerPoint</Application>
  <PresentationFormat>A4 210 x 297 mm</PresentationFormat>
  <Paragraphs>52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6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端千晶</dc:creator>
  <cp:lastModifiedBy>川端千晶</cp:lastModifiedBy>
  <cp:revision>30</cp:revision>
  <dcterms:created xsi:type="dcterms:W3CDTF">2022-08-06T23:31:53Z</dcterms:created>
  <dcterms:modified xsi:type="dcterms:W3CDTF">2023-06-29T18:09:31Z</dcterms:modified>
</cp:coreProperties>
</file>